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5" r:id="rId3"/>
    <p:sldId id="267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486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FD0C35-FEB0-46F2-A053-F382713CB543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D3EEDA-349F-42D6-B0F1-5E439F84486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476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b="1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D3EEDA-349F-42D6-B0F1-5E439F84486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05876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-10-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6.tiff"/><Relationship Id="rId7" Type="http://schemas.openxmlformats.org/officeDocument/2006/relationships/image" Target="../media/image20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2025" y="1211501"/>
            <a:ext cx="4104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i,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6" name="Picture 3" descr="H:\免疫荧光整理20200619\GFP-GRB2+MC-STS1\0MIN\1\未标题-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8125" y="2348880"/>
            <a:ext cx="1530350" cy="1530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H:\免疫荧光整理20200619\GFP-GRB2+MC-STS1\0MIN\1\未标题-3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95936" y="2348880"/>
            <a:ext cx="1530350" cy="1530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9" descr="H:\免疫荧光整理20200619\GFP-GRB2+MC-STS1\2MIN\1\未标题-2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3746" y="3953269"/>
            <a:ext cx="1530000" cy="15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0" descr="H:\免疫荧光整理20200619\GFP-GRB2+MC-STS1\2MIN\1\未标题-3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0615" y="3953269"/>
            <a:ext cx="1530000" cy="15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32025" y="2975555"/>
            <a:ext cx="811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 min</a:t>
            </a:r>
            <a:endParaRPr lang="zh-CN" altLang="en-US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171337" y="4533603"/>
            <a:ext cx="7489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 min</a:t>
            </a:r>
            <a:endParaRPr lang="zh-CN" altLang="en-US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886764" y="2348880"/>
            <a:ext cx="1530350" cy="1530350"/>
            <a:chOff x="862243" y="923506"/>
            <a:chExt cx="1530350" cy="1530350"/>
          </a:xfrm>
        </p:grpSpPr>
        <p:pic>
          <p:nvPicPr>
            <p:cNvPr id="5" name="Picture 2" descr="H:\免疫荧光整理20200619\GFP-GRB2+MC-STS1\0MIN\1\未标题-1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2243" y="923506"/>
              <a:ext cx="1530350" cy="15303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9" name="直接连接符 18"/>
            <p:cNvCxnSpPr>
              <a:endCxn id="5" idx="2"/>
            </p:cNvCxnSpPr>
            <p:nvPr/>
          </p:nvCxnSpPr>
          <p:spPr>
            <a:xfrm>
              <a:off x="1115616" y="2060848"/>
              <a:ext cx="511802" cy="393008"/>
            </a:xfrm>
            <a:prstGeom prst="line">
              <a:avLst/>
            </a:prstGeom>
            <a:ln w="1270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组合 36"/>
          <p:cNvGrpSpPr/>
          <p:nvPr/>
        </p:nvGrpSpPr>
        <p:grpSpPr>
          <a:xfrm>
            <a:off x="875912" y="3956631"/>
            <a:ext cx="1530000" cy="1523275"/>
            <a:chOff x="6444208" y="3841331"/>
            <a:chExt cx="1530000" cy="1523275"/>
          </a:xfrm>
        </p:grpSpPr>
        <p:pic>
          <p:nvPicPr>
            <p:cNvPr id="1026" name="Picture 2" descr="C:\Users\Administrator\Desktop\免疫荧光整理20200619\荧光定量统计\GRB2-2MIN\图片2.png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44208" y="3841331"/>
              <a:ext cx="1530000" cy="15232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4" name="直接连接符 23"/>
            <p:cNvCxnSpPr/>
            <p:nvPr/>
          </p:nvCxnSpPr>
          <p:spPr>
            <a:xfrm flipH="1" flipV="1">
              <a:off x="6534782" y="4167864"/>
              <a:ext cx="89270" cy="729740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TextBox 28"/>
          <p:cNvSpPr txBox="1"/>
          <p:nvPr/>
        </p:nvSpPr>
        <p:spPr>
          <a:xfrm>
            <a:off x="1284153" y="1987139"/>
            <a:ext cx="13162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555776" y="1974054"/>
            <a:ext cx="13162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FP-GRB2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923928" y="1974054"/>
            <a:ext cx="1728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0152" y="2102722"/>
            <a:ext cx="2487168" cy="3377184"/>
          </a:xfrm>
          <a:prstGeom prst="rect">
            <a:avLst/>
          </a:prstGeom>
        </p:spPr>
      </p:pic>
      <p:cxnSp>
        <p:nvCxnSpPr>
          <p:cNvPr id="20" name="直接连接符 19"/>
          <p:cNvCxnSpPr/>
          <p:nvPr/>
        </p:nvCxnSpPr>
        <p:spPr>
          <a:xfrm>
            <a:off x="5154690" y="3717032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5148064" y="5301208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566064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9822" y="2638423"/>
            <a:ext cx="1530000" cy="156625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6004" y="2638423"/>
            <a:ext cx="1530000" cy="1566256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4683" y="3135868"/>
            <a:ext cx="811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 min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13995" y="4693916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 min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6117" y="4302602"/>
            <a:ext cx="1530000" cy="1492377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1073" y="4293096"/>
            <a:ext cx="1530000" cy="1492377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234618" y="2270068"/>
            <a:ext cx="13162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654627" y="2256983"/>
            <a:ext cx="13162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FP-GRB2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042930" y="2256983"/>
            <a:ext cx="1728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39" name="组合 38"/>
          <p:cNvGrpSpPr/>
          <p:nvPr/>
        </p:nvGrpSpPr>
        <p:grpSpPr>
          <a:xfrm>
            <a:off x="827652" y="2638423"/>
            <a:ext cx="1530000" cy="1566256"/>
            <a:chOff x="852666" y="1052736"/>
            <a:chExt cx="1530000" cy="1566256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2666" y="1052736"/>
              <a:ext cx="1530000" cy="1566256"/>
            </a:xfrm>
            <a:prstGeom prst="rect">
              <a:avLst/>
            </a:prstGeom>
          </p:spPr>
        </p:pic>
        <p:cxnSp>
          <p:nvCxnSpPr>
            <p:cNvPr id="21" name="直接连接符 20"/>
            <p:cNvCxnSpPr/>
            <p:nvPr/>
          </p:nvCxnSpPr>
          <p:spPr>
            <a:xfrm flipH="1">
              <a:off x="1648308" y="1704033"/>
              <a:ext cx="498316" cy="648072"/>
            </a:xfrm>
            <a:prstGeom prst="line">
              <a:avLst/>
            </a:prstGeom>
            <a:ln w="12700">
              <a:solidFill>
                <a:schemeClr val="bg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组合 37"/>
          <p:cNvGrpSpPr/>
          <p:nvPr/>
        </p:nvGrpSpPr>
        <p:grpSpPr>
          <a:xfrm>
            <a:off x="827652" y="4294481"/>
            <a:ext cx="1530000" cy="1492377"/>
            <a:chOff x="852666" y="2708794"/>
            <a:chExt cx="1530000" cy="1492377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2666" y="2708794"/>
              <a:ext cx="1530000" cy="1492377"/>
            </a:xfrm>
            <a:prstGeom prst="rect">
              <a:avLst/>
            </a:prstGeom>
          </p:spPr>
        </p:pic>
        <p:cxnSp>
          <p:nvCxnSpPr>
            <p:cNvPr id="26" name="直接连接符 25"/>
            <p:cNvCxnSpPr/>
            <p:nvPr/>
          </p:nvCxnSpPr>
          <p:spPr>
            <a:xfrm flipH="1">
              <a:off x="1088764" y="2998874"/>
              <a:ext cx="874171" cy="98066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Box 3"/>
          <p:cNvSpPr txBox="1"/>
          <p:nvPr/>
        </p:nvSpPr>
        <p:spPr>
          <a:xfrm>
            <a:off x="132025" y="1211501"/>
            <a:ext cx="4104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i,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0672" y="2132856"/>
            <a:ext cx="2847644" cy="3943987"/>
          </a:xfrm>
          <a:prstGeom prst="rect">
            <a:avLst/>
          </a:prstGeom>
        </p:spPr>
      </p:pic>
      <p:cxnSp>
        <p:nvCxnSpPr>
          <p:cNvPr id="19" name="直接连接符 18"/>
          <p:cNvCxnSpPr/>
          <p:nvPr/>
        </p:nvCxnSpPr>
        <p:spPr>
          <a:xfrm>
            <a:off x="5154690" y="3976036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5154690" y="5517232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442523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39305" y="2031429"/>
            <a:ext cx="13162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FFC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erge</a:t>
            </a:r>
            <a:endParaRPr lang="zh-CN" altLang="en-US" sz="1600" b="1" dirty="0">
              <a:solidFill>
                <a:srgbClr val="FFC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655600" y="2031429"/>
            <a:ext cx="13162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00B05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FP-GRB2</a:t>
            </a:r>
            <a:endParaRPr lang="zh-CN" altLang="en-US" sz="1600" b="1" dirty="0">
              <a:solidFill>
                <a:srgbClr val="00B05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9697" y="2918333"/>
            <a:ext cx="811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 min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39009" y="4476381"/>
            <a:ext cx="6880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 min</a:t>
            </a:r>
            <a:endParaRPr lang="zh-CN" altLang="en-US" sz="1600" b="1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5627" y="2408780"/>
            <a:ext cx="1530000" cy="152334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7534" y="2408780"/>
            <a:ext cx="1530000" cy="1523348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5627" y="3996745"/>
            <a:ext cx="1530000" cy="1562467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2666" y="3996745"/>
            <a:ext cx="1530000" cy="1562467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7534" y="3985456"/>
            <a:ext cx="1530000" cy="1562467"/>
          </a:xfrm>
          <a:prstGeom prst="rect">
            <a:avLst/>
          </a:prstGeom>
        </p:spPr>
      </p:pic>
      <p:grpSp>
        <p:nvGrpSpPr>
          <p:cNvPr id="22" name="组合 21"/>
          <p:cNvGrpSpPr/>
          <p:nvPr/>
        </p:nvGrpSpPr>
        <p:grpSpPr>
          <a:xfrm>
            <a:off x="873827" y="2408780"/>
            <a:ext cx="1530000" cy="1523348"/>
            <a:chOff x="873827" y="1040628"/>
            <a:chExt cx="1530000" cy="1523348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3827" y="1040628"/>
              <a:ext cx="1530000" cy="1523348"/>
            </a:xfrm>
            <a:prstGeom prst="rect">
              <a:avLst/>
            </a:prstGeom>
          </p:spPr>
        </p:pic>
        <p:cxnSp>
          <p:nvCxnSpPr>
            <p:cNvPr id="19" name="直接连接符 18"/>
            <p:cNvCxnSpPr/>
            <p:nvPr/>
          </p:nvCxnSpPr>
          <p:spPr>
            <a:xfrm flipH="1" flipV="1">
              <a:off x="1623861" y="1159174"/>
              <a:ext cx="610016" cy="665706"/>
            </a:xfrm>
            <a:prstGeom prst="line">
              <a:avLst/>
            </a:prstGeom>
            <a:ln w="12700">
              <a:solidFill>
                <a:schemeClr val="bg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3" name="直接连接符 22"/>
          <p:cNvCxnSpPr/>
          <p:nvPr/>
        </p:nvCxnSpPr>
        <p:spPr>
          <a:xfrm flipH="1" flipV="1">
            <a:off x="1115616" y="5057998"/>
            <a:ext cx="813254" cy="243210"/>
          </a:xfrm>
          <a:prstGeom prst="line">
            <a:avLst/>
          </a:prstGeom>
          <a:ln w="12700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3"/>
          <p:cNvSpPr txBox="1"/>
          <p:nvPr/>
        </p:nvSpPr>
        <p:spPr>
          <a:xfrm>
            <a:off x="132025" y="1211501"/>
            <a:ext cx="41044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i,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TextBox 15"/>
          <p:cNvSpPr txBox="1"/>
          <p:nvPr/>
        </p:nvSpPr>
        <p:spPr>
          <a:xfrm>
            <a:off x="4042930" y="2031429"/>
            <a:ext cx="1728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rgbClr val="FF0000"/>
                </a:solidFill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Cherry-STS1</a:t>
            </a:r>
            <a:endParaRPr lang="zh-CN" altLang="en-US" sz="1600" b="1" dirty="0">
              <a:solidFill>
                <a:srgbClr val="FF0000"/>
              </a:solidFill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8" name="直接连接符 17"/>
          <p:cNvCxnSpPr/>
          <p:nvPr/>
        </p:nvCxnSpPr>
        <p:spPr>
          <a:xfrm>
            <a:off x="5154690" y="3717032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5183138" y="5301208"/>
            <a:ext cx="25295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图片 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5432" y="1774144"/>
            <a:ext cx="3358896" cy="43159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2274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2</TotalTime>
  <Words>40</Words>
  <Application>Microsoft Office PowerPoint</Application>
  <PresentationFormat>全屏显示(4:3)</PresentationFormat>
  <Paragraphs>19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Arial Unicode MS</vt:lpstr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xiao</dc:creator>
  <cp:lastModifiedBy>Windows 用户</cp:lastModifiedBy>
  <cp:revision>58</cp:revision>
  <dcterms:created xsi:type="dcterms:W3CDTF">2020-09-30T05:25:52Z</dcterms:created>
  <dcterms:modified xsi:type="dcterms:W3CDTF">2020-10-27T09:35:56Z</dcterms:modified>
</cp:coreProperties>
</file>